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BF802-7B24-451B-9258-C5681294F5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F4551-DC6A-4649-BCD2-78662AC92D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6A233-4F82-42AE-8FC3-25F283C62D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7A34F-39DA-4906-B50C-FF415BE0D9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28F49-5590-4041-9CD0-1FE4397175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04653D-E665-4A5A-966C-57059A92BD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3031E-6E75-41CA-98D0-2F72E51DDE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6A429-6D64-4CAC-AF38-0702B17CBC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742AE-068C-4B38-B18B-506134BD82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F4763-E500-406A-A1C6-9AE836A974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947E7-88D8-4AD0-AF59-104E27072D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1F86C-EFDF-452F-8091-8E08031350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5E9447-EAC1-45F8-B63A-79790E22DE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447920" y="2048040"/>
            <a:ext cx="1600200" cy="45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ERL Algorithm / IM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447920" y="457200"/>
            <a:ext cx="1600200" cy="916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al Binding Potential and Motif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581280" y="457200"/>
            <a:ext cx="259092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haracterized Prote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705720" y="457200"/>
            <a:ext cx="160020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croarray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962520" y="6024600"/>
            <a:ext cx="190476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nal Gene Li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038480" y="2895480"/>
            <a:ext cx="1600200" cy="1191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tential Metal Resistance Gene Li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809880" y="1295280"/>
            <a:ext cx="221004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LASTp(+reverse) / IM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657600" y="2057400"/>
            <a:ext cx="99072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D &lt;30%,                      E-val &lt;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105520" y="2057400"/>
            <a:ext cx="99036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D &gt;30%,                      E-val &gt;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-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257800" y="4454640"/>
            <a:ext cx="190512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ynteny/ Neighborhoo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752480" y="4419720"/>
            <a:ext cx="2743200" cy="855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hylogeny/ Alignment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substrates or classification (eg Cu or Zn- type ATPas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76920" y="9144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09680" y="1523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467480" y="14479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H="1">
            <a:off x="4724280" y="1752480"/>
            <a:ext cx="15264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876920" y="1752480"/>
            <a:ext cx="15228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680000" y="4724280"/>
            <a:ext cx="38088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876920" y="42670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876920" y="5334120"/>
            <a:ext cx="0" cy="5331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5791320" y="2666880"/>
            <a:ext cx="91440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334120" y="25909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3200040" y="2286000"/>
            <a:ext cx="304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124080" y="2666880"/>
            <a:ext cx="68580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553080" y="1981080"/>
            <a:ext cx="236232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LASTp(+reverse) / function (COG, pfam, KO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0" y="609480"/>
            <a:ext cx="12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ource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0" y="198108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hod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0" y="4572000"/>
            <a:ext cx="1371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dditional Analysi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1T06:17:16Z</dcterms:created>
  <dc:creator>Thoth</dc:creator>
  <dc:description/>
  <dc:language>en-US</dc:language>
  <cp:lastModifiedBy>Thoth</cp:lastModifiedBy>
  <dcterms:modified xsi:type="dcterms:W3CDTF">2012-02-01T06:54:10Z</dcterms:modified>
  <cp:revision>3</cp:revision>
  <dc:subject/>
  <dc:title>Slide 1</dc:title>
</cp:coreProperties>
</file>